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120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2108FD-F670-4796-9E9E-698CAA9ED5D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6B2E2F1-194F-44DA-BDD0-23649471B3F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E08982-C928-49A0-A716-08DDE6CC8F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3E531B-FDBA-40A1-82E6-958CFA36306E}" type="datetimeFigureOut">
              <a:rPr lang="en-US" smtClean="0"/>
              <a:t>12/2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718A07-3994-46D2-91B0-ADBC7AEF2D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D25782-B489-47A9-8CA4-FBA9AD3F4B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EFB54D-E043-4C0F-9C86-27C0533DA8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27185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49F2D4-E36C-4B4C-8711-A87F6D2C84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A16D34B-8412-42D0-9F4C-5C3B6FA1EAC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1F9F7B-AFE0-4368-88F6-7476F78357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3E531B-FDBA-40A1-82E6-958CFA36306E}" type="datetimeFigureOut">
              <a:rPr lang="en-US" smtClean="0"/>
              <a:t>12/2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7408C5-9BE0-4721-AD48-6B83E318C5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7A57EF-15AD-436C-B307-AB09CC9139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EFB54D-E043-4C0F-9C86-27C0533DA8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87672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01D7A07-E652-4B46-A0F3-9BCB9A1989C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1CF0F61-7C1F-4949-B1AD-457ADE43F68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CB48E5-D944-458C-A5E9-039BC37EF8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3E531B-FDBA-40A1-82E6-958CFA36306E}" type="datetimeFigureOut">
              <a:rPr lang="en-US" smtClean="0"/>
              <a:t>12/2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50D4A8-EE86-4B13-9A66-144649D4E9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EB174F-F9E4-41A4-9929-6F2832A445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EFB54D-E043-4C0F-9C86-27C0533DA8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11421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62091B-7006-402B-B456-2D000F0756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E30D9DC-E148-47D8-86F5-F11F8E0ABC2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8394FC-465F-4F5A-AADE-1D734EBCD0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3E531B-FDBA-40A1-82E6-958CFA36306E}" type="datetimeFigureOut">
              <a:rPr lang="en-US" smtClean="0"/>
              <a:t>12/2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FEAC7A-1D6A-4A7B-9DCB-89DDE71F50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73D6E9-26D8-49A1-A753-DBF09ADB99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EFB54D-E043-4C0F-9C86-27C0533DA8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79557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DB8ED6-B59D-4405-AA47-791D3C3990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E36B3AA-9CF5-454C-88C6-D44AC30453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F69E26-9029-46B9-98C0-18D349BB85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3E531B-FDBA-40A1-82E6-958CFA36306E}" type="datetimeFigureOut">
              <a:rPr lang="en-US" smtClean="0"/>
              <a:t>12/2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6C101B-C646-4CB0-A3FE-1018A6AD0A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E9E1BC-8A63-45CE-831F-1E483B50C2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EFB54D-E043-4C0F-9C86-27C0533DA8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97683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DC840D-008D-4FD7-A093-07F5F7C0E0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91F208D-2D0C-43B2-8450-05CE190DC49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FF93925-F224-4980-AD5E-6F4621FA1C1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915A323-DFA8-48E2-8A3B-1DCFF24AB0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3E531B-FDBA-40A1-82E6-958CFA36306E}" type="datetimeFigureOut">
              <a:rPr lang="en-US" smtClean="0"/>
              <a:t>12/2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9DBE0B1-0411-4B1C-8901-EEC1902B03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35860E6-2EB6-4D6E-AA0A-B43483620B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EFB54D-E043-4C0F-9C86-27C0533DA8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32494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1EE356-1332-4583-A365-F5EB2064D8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85C7087-7EFA-4761-8CC2-A8EC903244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D11BB1B-91AA-44CE-81A6-2FFBEF57CF8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EEADE4E-BF82-4DE2-A63E-C0E7474183F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79C4797-5879-4BBE-B601-C987FBB770B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0E2D598-EDAF-4F53-966E-5713219588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3E531B-FDBA-40A1-82E6-958CFA36306E}" type="datetimeFigureOut">
              <a:rPr lang="en-US" smtClean="0"/>
              <a:t>12/20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AC0B6AC-B198-406F-909B-32D549DBE8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39AC540-638B-44A3-9C58-3D72308D44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EFB54D-E043-4C0F-9C86-27C0533DA8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66982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643F4A-BE21-45E2-BCC1-20CDA80AEA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70125EE-9A91-4BFB-98A8-ED2EFB8188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3E531B-FDBA-40A1-82E6-958CFA36306E}" type="datetimeFigureOut">
              <a:rPr lang="en-US" smtClean="0"/>
              <a:t>12/20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E6AC5CD-B2D6-44FD-966F-32B4C9DC8B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A07BD17-EBE6-485E-8577-0119E2D437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EFB54D-E043-4C0F-9C86-27C0533DA8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71004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1FED13A-93BE-408A-A788-D10EF36473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3E531B-FDBA-40A1-82E6-958CFA36306E}" type="datetimeFigureOut">
              <a:rPr lang="en-US" smtClean="0"/>
              <a:t>12/20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178262E-E617-4745-BBC0-50A1E855E0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928C3F3-6A50-410C-B3CD-E2FAAC0337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EFB54D-E043-4C0F-9C86-27C0533DA8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1041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03E0C2-28D2-4040-A8B7-CE566481E1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87E64B3-B88D-45F2-9844-84FAF53E447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CCB65B8-9590-4AD6-8ADA-6B47E9D08C4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44EC8D0-CF37-4764-893F-51F175C39A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3E531B-FDBA-40A1-82E6-958CFA36306E}" type="datetimeFigureOut">
              <a:rPr lang="en-US" smtClean="0"/>
              <a:t>12/2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CE074C2-BCD2-415F-986E-8E65C85439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0465C8-93BF-47AC-A501-8B7F786742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EFB54D-E043-4C0F-9C86-27C0533DA8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54083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466D84-561C-4784-BDEE-07D80D2437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F7B4A42-6BB8-44E7-9BC8-991669F5DE2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7B713F8-DB50-4DBD-952E-E03E7C6AA5C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D66A9A6-17A5-4A4A-A7A3-C317A7FF70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3E531B-FDBA-40A1-82E6-958CFA36306E}" type="datetimeFigureOut">
              <a:rPr lang="en-US" smtClean="0"/>
              <a:t>12/2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9A768C4-2801-45A7-8859-17E8FF8038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A134A95-8A91-4582-BCA6-EF03077C0B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EFB54D-E043-4C0F-9C86-27C0533DA8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35693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6E992BA-4A1A-4086-8DD4-93BD349A5C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C1FF743-541B-4F37-A189-E6DCACAF24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333A62-9AA4-482C-ABD5-05AE2B9270E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3E531B-FDBA-40A1-82E6-958CFA36306E}" type="datetimeFigureOut">
              <a:rPr lang="en-US" smtClean="0"/>
              <a:t>12/2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1B941A-5117-4BE5-819F-AC767BEB5FA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6B130D-9F49-4A58-98B6-F17AF013F03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EFB54D-E043-4C0F-9C86-27C0533DA8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57730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5" Type="http://schemas.microsoft.com/office/2007/relationships/hdphoto" Target="../media/hdphoto4.wdp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5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microsoft.com/office/2007/relationships/hdphoto" Target="../media/hdphoto6.wdp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7.wdp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5" Type="http://schemas.microsoft.com/office/2007/relationships/hdphoto" Target="../media/hdphoto8.wdp"/><Relationship Id="rId4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9.wdp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5" Type="http://schemas.microsoft.com/office/2007/relationships/hdphoto" Target="../media/hdphoto8.wdp"/><Relationship Id="rId4" Type="http://schemas.openxmlformats.org/officeDocument/2006/relationships/image" Target="../media/image10.png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hdphoto" Target="../media/hdphoto10.wdp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5" Type="http://schemas.microsoft.com/office/2007/relationships/hdphoto" Target="../media/hdphoto11.wdp"/><Relationship Id="rId4" Type="http://schemas.openxmlformats.org/officeDocument/2006/relationships/image" Target="../media/image12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microsoft.com/office/2007/relationships/hdphoto" Target="../media/hdphoto12.wdp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5" Type="http://schemas.microsoft.com/office/2007/relationships/hdphoto" Target="../media/hdphoto11.wdp"/><Relationship Id="rId4" Type="http://schemas.openxmlformats.org/officeDocument/2006/relationships/image" Target="../media/image1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>
            <a:extLst>
              <a:ext uri="{FF2B5EF4-FFF2-40B4-BE49-F238E27FC236}">
                <a16:creationId xmlns:a16="http://schemas.microsoft.com/office/drawing/2014/main" id="{B53DBCAA-9E16-49AE-810E-0695DEB50033}"/>
              </a:ext>
            </a:extLst>
          </p:cNvPr>
          <p:cNvGrpSpPr/>
          <p:nvPr/>
        </p:nvGrpSpPr>
        <p:grpSpPr>
          <a:xfrm>
            <a:off x="447817" y="527880"/>
            <a:ext cx="2192754" cy="834954"/>
            <a:chOff x="447817" y="527880"/>
            <a:chExt cx="2192754" cy="834954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877D3A6A-7BF3-4231-AC33-83F168510BC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rcRect l="20786" t="23339" r="59686" b="65565"/>
            <a:stretch/>
          </p:blipFill>
          <p:spPr>
            <a:xfrm>
              <a:off x="447817" y="566665"/>
              <a:ext cx="1428942" cy="323677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C93C88D3-5009-47BB-A2DD-8AB562624536}"/>
                </a:ext>
              </a:extLst>
            </p:cNvPr>
            <p:cNvSpPr txBox="1"/>
            <p:nvPr/>
          </p:nvSpPr>
          <p:spPr>
            <a:xfrm>
              <a:off x="1867602" y="527880"/>
              <a:ext cx="772969" cy="461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RIPK3</a:t>
              </a:r>
            </a:p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(57 kDa)</a:t>
              </a:r>
            </a:p>
          </p:txBody>
        </p:sp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B9971F68-274F-430E-A60E-9DD254FD926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rcRect l="21070" t="30385" r="60682" b="60854"/>
            <a:stretch/>
          </p:blipFill>
          <p:spPr>
            <a:xfrm>
              <a:off x="447817" y="930277"/>
              <a:ext cx="1428941" cy="273495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A5B7AF22-5C7E-4A81-85F7-3468974ED78F}"/>
                </a:ext>
              </a:extLst>
            </p:cNvPr>
            <p:cNvSpPr txBox="1"/>
            <p:nvPr/>
          </p:nvSpPr>
          <p:spPr>
            <a:xfrm>
              <a:off x="1867602" y="901169"/>
              <a:ext cx="77296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RIPK3 </a:t>
              </a:r>
            </a:p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(57 kDa)</a:t>
              </a:r>
            </a:p>
          </p:txBody>
        </p:sp>
      </p:grpSp>
      <p:pic>
        <p:nvPicPr>
          <p:cNvPr id="12" name="Picture 11">
            <a:extLst>
              <a:ext uri="{FF2B5EF4-FFF2-40B4-BE49-F238E27FC236}">
                <a16:creationId xmlns:a16="http://schemas.microsoft.com/office/drawing/2014/main" id="{24C7B868-78A0-44CB-A1AA-7B4A572B0A8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rcRect l="20786" t="6677" r="18857" b="8374"/>
          <a:stretch/>
        </p:blipFill>
        <p:spPr>
          <a:xfrm>
            <a:off x="3800617" y="91440"/>
            <a:ext cx="4416552" cy="2478024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299A20BD-25CE-481B-9F6F-08ADEC3D0A9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rcRect l="21070" t="1070" r="22529" b="10178"/>
          <a:stretch/>
        </p:blipFill>
        <p:spPr>
          <a:xfrm>
            <a:off x="3800617" y="2676721"/>
            <a:ext cx="4416552" cy="2770632"/>
          </a:xfrm>
          <a:prstGeom prst="rect">
            <a:avLst/>
          </a:prstGeom>
        </p:spPr>
      </p:pic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BC2AC1BF-6FEA-4D73-9ED5-6D16F1CF8996}"/>
              </a:ext>
            </a:extLst>
          </p:cNvPr>
          <p:cNvCxnSpPr/>
          <p:nvPr/>
        </p:nvCxnSpPr>
        <p:spPr>
          <a:xfrm flipV="1">
            <a:off x="1876758" y="127836"/>
            <a:ext cx="1933015" cy="43644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45857F0A-F573-4441-AAAE-F7ED03B66E42}"/>
              </a:ext>
            </a:extLst>
          </p:cNvPr>
          <p:cNvCxnSpPr/>
          <p:nvPr/>
        </p:nvCxnSpPr>
        <p:spPr>
          <a:xfrm>
            <a:off x="1867602" y="1203772"/>
            <a:ext cx="1933015" cy="152114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418521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3F7D7A77-2158-4D7D-92D3-9A63EA159FD6}"/>
              </a:ext>
            </a:extLst>
          </p:cNvPr>
          <p:cNvGrpSpPr/>
          <p:nvPr/>
        </p:nvGrpSpPr>
        <p:grpSpPr>
          <a:xfrm>
            <a:off x="140291" y="395370"/>
            <a:ext cx="1789036" cy="919507"/>
            <a:chOff x="9968624" y="761868"/>
            <a:chExt cx="1789036" cy="919507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368C4943-E562-4A32-9027-D4D3D504E61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20000"/>
                      </a14:imgEffect>
                    </a14:imgLayer>
                  </a14:imgProps>
                </a:ext>
              </a:extLst>
            </a:blip>
            <a:srcRect l="23083" t="33361" r="61697" b="57611"/>
            <a:stretch/>
          </p:blipFill>
          <p:spPr>
            <a:xfrm>
              <a:off x="9968624" y="870089"/>
              <a:ext cx="1225261" cy="344823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8E7D7545-A264-4C5B-9116-D8DCD050853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40000" contrast="40000"/>
                      </a14:imgEffect>
                    </a14:imgLayer>
                  </a14:imgProps>
                </a:ext>
              </a:extLst>
            </a:blip>
            <a:srcRect l="22266" t="41180" r="61606" b="49220"/>
            <a:stretch/>
          </p:blipFill>
          <p:spPr>
            <a:xfrm>
              <a:off x="9968624" y="1243437"/>
              <a:ext cx="1225261" cy="344823"/>
            </a:xfrm>
            <a:prstGeom prst="rect">
              <a:avLst/>
            </a:prstGeom>
          </p:spPr>
        </p:pic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CF84ABEA-7A28-4200-BCE0-D79228ACE8AC}"/>
                </a:ext>
              </a:extLst>
            </p:cNvPr>
            <p:cNvGrpSpPr/>
            <p:nvPr/>
          </p:nvGrpSpPr>
          <p:grpSpPr>
            <a:xfrm>
              <a:off x="11115242" y="761868"/>
              <a:ext cx="642418" cy="442238"/>
              <a:chOff x="11115242" y="761868"/>
              <a:chExt cx="642418" cy="442238"/>
            </a:xfrm>
          </p:grpSpPr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38C0AB67-44EA-4D0C-9B0B-42B28802E367}"/>
                  </a:ext>
                </a:extLst>
              </p:cNvPr>
              <p:cNvSpPr txBox="1"/>
              <p:nvPr/>
            </p:nvSpPr>
            <p:spPr>
              <a:xfrm>
                <a:off x="11157487" y="761868"/>
                <a:ext cx="516027" cy="2592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ZBP1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84E79A33-A999-428B-B5F0-C7CAD30E18B0}"/>
                  </a:ext>
                </a:extLst>
              </p:cNvPr>
              <p:cNvSpPr txBox="1"/>
              <p:nvPr/>
            </p:nvSpPr>
            <p:spPr>
              <a:xfrm>
                <a:off x="11115242" y="944871"/>
                <a:ext cx="642418" cy="25923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(55 </a:t>
                </a:r>
                <a:r>
                  <a:rPr lang="en-US" sz="1200" dirty="0" err="1"/>
                  <a:t>kDa</a:t>
                </a:r>
                <a:r>
                  <a:rPr lang="en-US" sz="1200" dirty="0"/>
                  <a:t>)</a:t>
                </a:r>
              </a:p>
            </p:txBody>
          </p:sp>
        </p:grpSp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5BF94F80-8146-4526-99A1-250D52E317E1}"/>
                </a:ext>
              </a:extLst>
            </p:cNvPr>
            <p:cNvGrpSpPr/>
            <p:nvPr/>
          </p:nvGrpSpPr>
          <p:grpSpPr>
            <a:xfrm>
              <a:off x="11146115" y="1253669"/>
              <a:ext cx="607552" cy="427706"/>
              <a:chOff x="11146115" y="1253669"/>
              <a:chExt cx="607552" cy="427706"/>
            </a:xfrm>
          </p:grpSpPr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0F911DD5-7336-4A16-8F03-CA42C23D4733}"/>
                  </a:ext>
                </a:extLst>
              </p:cNvPr>
              <p:cNvSpPr txBox="1"/>
              <p:nvPr/>
            </p:nvSpPr>
            <p:spPr>
              <a:xfrm>
                <a:off x="11155919" y="1253669"/>
                <a:ext cx="561063" cy="25923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200" dirty="0"/>
                  <a:t>β</a:t>
                </a:r>
                <a:r>
                  <a:rPr lang="en-US" sz="1200" dirty="0"/>
                  <a:t>-actin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7F1386A2-9901-468B-B3BF-4CE9B7EC8981}"/>
                  </a:ext>
                </a:extLst>
              </p:cNvPr>
              <p:cNvSpPr txBox="1"/>
              <p:nvPr/>
            </p:nvSpPr>
            <p:spPr>
              <a:xfrm>
                <a:off x="11146115" y="1422140"/>
                <a:ext cx="607552" cy="25923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43 </a:t>
                </a:r>
                <a:r>
                  <a:rPr lang="en-US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pic>
        <p:nvPicPr>
          <p:cNvPr id="12" name="Picture 11">
            <a:extLst>
              <a:ext uri="{FF2B5EF4-FFF2-40B4-BE49-F238E27FC236}">
                <a16:creationId xmlns:a16="http://schemas.microsoft.com/office/drawing/2014/main" id="{7DF511A2-38F1-4E2A-8B71-AF5D3D47699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rcRect l="21379" t="7724" r="19897" b="5371"/>
          <a:stretch/>
        </p:blipFill>
        <p:spPr>
          <a:xfrm>
            <a:off x="3102825" y="109727"/>
            <a:ext cx="4727448" cy="3319273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65C37387-87F9-46C1-BC12-9E6EA7B361C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40000" contrast="40000"/>
                    </a14:imgEffect>
                  </a14:imgLayer>
                </a14:imgProps>
              </a:ext>
            </a:extLst>
          </a:blip>
          <a:srcRect l="19859" t="14728" r="23450" b="13482"/>
          <a:stretch/>
        </p:blipFill>
        <p:spPr>
          <a:xfrm>
            <a:off x="3102825" y="3584449"/>
            <a:ext cx="4306824" cy="2578607"/>
          </a:xfrm>
          <a:prstGeom prst="rect">
            <a:avLst/>
          </a:prstGeom>
        </p:spPr>
      </p:pic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6A405C9F-2535-4C75-A299-0BEC46FF8531}"/>
              </a:ext>
            </a:extLst>
          </p:cNvPr>
          <p:cNvCxnSpPr>
            <a:stCxn id="9" idx="1"/>
          </p:cNvCxnSpPr>
          <p:nvPr/>
        </p:nvCxnSpPr>
        <p:spPr>
          <a:xfrm flipV="1">
            <a:off x="1329154" y="265176"/>
            <a:ext cx="1852958" cy="25981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C5C526DC-9322-4EDE-A6F2-7E9F848A12C4}"/>
              </a:ext>
            </a:extLst>
          </p:cNvPr>
          <p:cNvCxnSpPr/>
          <p:nvPr/>
        </p:nvCxnSpPr>
        <p:spPr>
          <a:xfrm>
            <a:off x="2798064" y="1221762"/>
            <a:ext cx="38404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09742F86-69DA-4E91-A960-15F0B291C7F8}"/>
              </a:ext>
            </a:extLst>
          </p:cNvPr>
          <p:cNvCxnSpPr>
            <a:stCxn id="8" idx="1"/>
          </p:cNvCxnSpPr>
          <p:nvPr/>
        </p:nvCxnSpPr>
        <p:spPr>
          <a:xfrm>
            <a:off x="1317782" y="1185260"/>
            <a:ext cx="1785043" cy="251806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872814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BBA1512D-999C-4FA9-9087-63D097BCE6EA}"/>
              </a:ext>
            </a:extLst>
          </p:cNvPr>
          <p:cNvGrpSpPr/>
          <p:nvPr/>
        </p:nvGrpSpPr>
        <p:grpSpPr>
          <a:xfrm>
            <a:off x="82296" y="308329"/>
            <a:ext cx="3755928" cy="739547"/>
            <a:chOff x="456942" y="1259305"/>
            <a:chExt cx="3755928" cy="739547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CBC5F88E-7A78-493C-B938-CAC5B7344962}"/>
                </a:ext>
              </a:extLst>
            </p:cNvPr>
            <p:cNvGrpSpPr/>
            <p:nvPr/>
          </p:nvGrpSpPr>
          <p:grpSpPr>
            <a:xfrm>
              <a:off x="1299946" y="1316650"/>
              <a:ext cx="1704969" cy="673750"/>
              <a:chOff x="5656746" y="4878991"/>
              <a:chExt cx="1313880" cy="511288"/>
            </a:xfrm>
          </p:grpSpPr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5EAE899C-244C-4577-BAD3-7710FD1E47F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rcRect l="22526" t="39158" r="58758" b="52846"/>
              <a:stretch/>
            </p:blipFill>
            <p:spPr>
              <a:xfrm>
                <a:off x="5656746" y="4878991"/>
                <a:ext cx="1313880" cy="260903"/>
              </a:xfrm>
              <a:prstGeom prst="rect">
                <a:avLst/>
              </a:prstGeom>
            </p:spPr>
          </p:pic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86924CBD-9352-4DD7-AB32-57DCCE3A10A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rcRect l="21579" t="54712" r="58018" b="38321"/>
              <a:stretch/>
            </p:blipFill>
            <p:spPr>
              <a:xfrm>
                <a:off x="5656746" y="5182793"/>
                <a:ext cx="1307095" cy="207486"/>
              </a:xfrm>
              <a:prstGeom prst="rect">
                <a:avLst/>
              </a:prstGeom>
            </p:spPr>
          </p:pic>
        </p:grp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9E1D987B-2141-4430-9FD9-BE8E78EFB04C}"/>
                </a:ext>
              </a:extLst>
            </p:cNvPr>
            <p:cNvSpPr txBox="1"/>
            <p:nvPr/>
          </p:nvSpPr>
          <p:spPr>
            <a:xfrm>
              <a:off x="818194" y="1316650"/>
              <a:ext cx="4716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IE1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C7D6E866-2789-48C0-BDEC-FC613373F39E}"/>
                </a:ext>
              </a:extLst>
            </p:cNvPr>
            <p:cNvSpPr txBox="1"/>
            <p:nvPr/>
          </p:nvSpPr>
          <p:spPr>
            <a:xfrm>
              <a:off x="2938162" y="1259305"/>
              <a:ext cx="127470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(72-95 </a:t>
              </a:r>
              <a:r>
                <a:rPr lang="en-US" dirty="0" err="1"/>
                <a:t>kDa</a:t>
              </a:r>
              <a:r>
                <a:rPr lang="en-US" dirty="0"/>
                <a:t>)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E14DBB9E-B61B-424B-97CF-16C715E34827}"/>
                </a:ext>
              </a:extLst>
            </p:cNvPr>
            <p:cNvSpPr txBox="1"/>
            <p:nvPr/>
          </p:nvSpPr>
          <p:spPr>
            <a:xfrm>
              <a:off x="3016407" y="1629520"/>
              <a:ext cx="8290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43 </a:t>
              </a:r>
              <a:r>
                <a:rPr lang="en-US" dirty="0" err="1"/>
                <a:t>kDa</a:t>
              </a:r>
              <a:endParaRPr lang="en-US" dirty="0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5D190C12-A56F-43D7-8535-0CE6251BBC3D}"/>
                </a:ext>
              </a:extLst>
            </p:cNvPr>
            <p:cNvSpPr txBox="1"/>
            <p:nvPr/>
          </p:nvSpPr>
          <p:spPr>
            <a:xfrm>
              <a:off x="456942" y="1629520"/>
              <a:ext cx="83869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dirty="0"/>
                <a:t>β</a:t>
              </a:r>
              <a:r>
                <a:rPr lang="en-US" dirty="0"/>
                <a:t>-actin</a:t>
              </a:r>
            </a:p>
          </p:txBody>
        </p:sp>
      </p:grpSp>
      <p:pic>
        <p:nvPicPr>
          <p:cNvPr id="18" name="Picture 17">
            <a:extLst>
              <a:ext uri="{FF2B5EF4-FFF2-40B4-BE49-F238E27FC236}">
                <a16:creationId xmlns:a16="http://schemas.microsoft.com/office/drawing/2014/main" id="{7568C08D-E77E-414A-BF27-CE59336CC78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rcRect l="18825" t="17773" r="16935" b="21121"/>
          <a:stretch/>
        </p:blipFill>
        <p:spPr>
          <a:xfrm>
            <a:off x="5385816" y="75296"/>
            <a:ext cx="5852160" cy="2627319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6EA9BAA6-99D8-41C9-B31E-26E84ED15C7C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rcRect l="18391" t="13501" r="18143" b="4443"/>
          <a:stretch/>
        </p:blipFill>
        <p:spPr>
          <a:xfrm>
            <a:off x="5385816" y="2823968"/>
            <a:ext cx="5852160" cy="3571816"/>
          </a:xfrm>
          <a:prstGeom prst="rect">
            <a:avLst/>
          </a:prstGeom>
        </p:spPr>
      </p:pic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C1CF7A25-6A6E-44B5-A536-C1E589F0CA10}"/>
              </a:ext>
            </a:extLst>
          </p:cNvPr>
          <p:cNvCxnSpPr/>
          <p:nvPr/>
        </p:nvCxnSpPr>
        <p:spPr>
          <a:xfrm flipV="1">
            <a:off x="2563516" y="365674"/>
            <a:ext cx="2822300" cy="31198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92B889A4-CBC8-418A-9304-9F857952ECA4}"/>
              </a:ext>
            </a:extLst>
          </p:cNvPr>
          <p:cNvCxnSpPr/>
          <p:nvPr/>
        </p:nvCxnSpPr>
        <p:spPr>
          <a:xfrm>
            <a:off x="2563516" y="1039424"/>
            <a:ext cx="2758292" cy="253588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2062180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B47C09A6-3488-4B2A-9CFC-ACCB40A1830E}"/>
              </a:ext>
            </a:extLst>
          </p:cNvPr>
          <p:cNvGrpSpPr/>
          <p:nvPr/>
        </p:nvGrpSpPr>
        <p:grpSpPr>
          <a:xfrm>
            <a:off x="123045" y="497933"/>
            <a:ext cx="3755928" cy="739547"/>
            <a:chOff x="380699" y="379210"/>
            <a:chExt cx="3755928" cy="739547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00E17936-4A85-4D9A-AB80-D7A021602D87}"/>
                </a:ext>
              </a:extLst>
            </p:cNvPr>
            <p:cNvGrpSpPr/>
            <p:nvPr/>
          </p:nvGrpSpPr>
          <p:grpSpPr>
            <a:xfrm>
              <a:off x="1167230" y="419486"/>
              <a:ext cx="1721269" cy="659130"/>
              <a:chOff x="7372555" y="4732231"/>
              <a:chExt cx="1355588" cy="527583"/>
            </a:xfrm>
          </p:grpSpPr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15C7477E-E291-46B1-9950-9F1024028C9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rcRect l="26832" t="53020" r="54296" b="38937"/>
              <a:stretch/>
            </p:blipFill>
            <p:spPr>
              <a:xfrm>
                <a:off x="7385390" y="4732231"/>
                <a:ext cx="1342753" cy="275190"/>
              </a:xfrm>
              <a:prstGeom prst="rect">
                <a:avLst/>
              </a:prstGeom>
            </p:spPr>
          </p:pic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E072DB93-EAF3-427F-892E-2F54150E86D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-20000" contrast="20000"/>
                        </a14:imgEffect>
                      </a14:imgLayer>
                    </a14:imgProps>
                  </a:ext>
                </a:extLst>
              </a:blip>
              <a:srcRect l="28071" t="52411" r="54102" b="41340"/>
              <a:stretch/>
            </p:blipFill>
            <p:spPr>
              <a:xfrm>
                <a:off x="7372555" y="5040966"/>
                <a:ext cx="1342753" cy="218848"/>
              </a:xfrm>
              <a:prstGeom prst="rect">
                <a:avLst/>
              </a:prstGeom>
            </p:spPr>
          </p:pic>
        </p:grp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62A17A6B-3E7E-4F12-8DE4-3C8518E5935D}"/>
                </a:ext>
              </a:extLst>
            </p:cNvPr>
            <p:cNvSpPr txBox="1"/>
            <p:nvPr/>
          </p:nvSpPr>
          <p:spPr>
            <a:xfrm>
              <a:off x="800045" y="419483"/>
              <a:ext cx="41389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E1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A993B58D-C6F9-41CD-902B-1F2A33AD5F07}"/>
                </a:ext>
              </a:extLst>
            </p:cNvPr>
            <p:cNvSpPr txBox="1"/>
            <p:nvPr/>
          </p:nvSpPr>
          <p:spPr>
            <a:xfrm>
              <a:off x="2861919" y="379210"/>
              <a:ext cx="127470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(40-43 </a:t>
              </a:r>
              <a:r>
                <a:rPr lang="en-US" dirty="0" err="1"/>
                <a:t>kDa</a:t>
              </a:r>
              <a:r>
                <a:rPr lang="en-US" dirty="0"/>
                <a:t>)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6F367540-A60C-4C71-A367-2B2F44C0F1E3}"/>
                </a:ext>
              </a:extLst>
            </p:cNvPr>
            <p:cNvSpPr txBox="1"/>
            <p:nvPr/>
          </p:nvSpPr>
          <p:spPr>
            <a:xfrm>
              <a:off x="2940164" y="749425"/>
              <a:ext cx="8290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43 </a:t>
              </a:r>
              <a:r>
                <a:rPr lang="en-US" dirty="0" err="1"/>
                <a:t>kDa</a:t>
              </a:r>
              <a:endParaRPr lang="en-US" dirty="0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B64A3851-32CB-48B7-813D-113BF2D699A6}"/>
                </a:ext>
              </a:extLst>
            </p:cNvPr>
            <p:cNvSpPr txBox="1"/>
            <p:nvPr/>
          </p:nvSpPr>
          <p:spPr>
            <a:xfrm>
              <a:off x="380699" y="749425"/>
              <a:ext cx="83869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dirty="0"/>
                <a:t>β</a:t>
              </a:r>
              <a:r>
                <a:rPr lang="en-US" dirty="0"/>
                <a:t>-actin</a:t>
              </a:r>
            </a:p>
          </p:txBody>
        </p:sp>
      </p:grpSp>
      <p:pic>
        <p:nvPicPr>
          <p:cNvPr id="18" name="Picture 17">
            <a:extLst>
              <a:ext uri="{FF2B5EF4-FFF2-40B4-BE49-F238E27FC236}">
                <a16:creationId xmlns:a16="http://schemas.microsoft.com/office/drawing/2014/main" id="{5056839D-C657-409F-BF59-F91BB160F1B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rcRect l="24233" t="27443" r="15419" b="1110"/>
          <a:stretch/>
        </p:blipFill>
        <p:spPr>
          <a:xfrm>
            <a:off x="5557366" y="146304"/>
            <a:ext cx="5452010" cy="3054096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8FF62212-88D4-4C0E-8984-8AD93618A05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20000"/>
                    </a14:imgEffect>
                  </a14:imgLayer>
                </a14:imgProps>
              </a:ext>
            </a:extLst>
          </a:blip>
          <a:srcRect l="23822" t="28796" r="17379" b="16030"/>
          <a:stretch/>
        </p:blipFill>
        <p:spPr>
          <a:xfrm>
            <a:off x="5535495" y="3429000"/>
            <a:ext cx="5559656" cy="2386584"/>
          </a:xfrm>
          <a:prstGeom prst="rect">
            <a:avLst/>
          </a:prstGeom>
        </p:spPr>
      </p:pic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9D0A0339-65B1-473B-84A0-206F6B98FAEF}"/>
              </a:ext>
            </a:extLst>
          </p:cNvPr>
          <p:cNvCxnSpPr/>
          <p:nvPr/>
        </p:nvCxnSpPr>
        <p:spPr>
          <a:xfrm flipV="1">
            <a:off x="2614548" y="292608"/>
            <a:ext cx="2942818" cy="20532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A2FAE8C9-5D5B-4A41-A5C2-387A925776EC}"/>
              </a:ext>
            </a:extLst>
          </p:cNvPr>
          <p:cNvCxnSpPr/>
          <p:nvPr/>
        </p:nvCxnSpPr>
        <p:spPr>
          <a:xfrm>
            <a:off x="2505456" y="1197339"/>
            <a:ext cx="3030039" cy="299975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937308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45FCF4F4-2833-4423-89DC-0B085938FF57}"/>
              </a:ext>
            </a:extLst>
          </p:cNvPr>
          <p:cNvGrpSpPr/>
          <p:nvPr/>
        </p:nvGrpSpPr>
        <p:grpSpPr>
          <a:xfrm>
            <a:off x="64008" y="473411"/>
            <a:ext cx="3470548" cy="744649"/>
            <a:chOff x="8257370" y="1314659"/>
            <a:chExt cx="3470548" cy="744649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9AAE991C-4D8B-4522-BF0F-3F84D0AC718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rcRect l="61952" t="30064" r="20961" b="63058"/>
            <a:stretch/>
          </p:blipFill>
          <p:spPr>
            <a:xfrm>
              <a:off x="9088483" y="1416375"/>
              <a:ext cx="1680784" cy="244080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CBFF5EC0-E1DF-4D6C-A98B-57B95092BB8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rcRect l="62550" t="51303" r="18576" b="40322"/>
            <a:stretch/>
          </p:blipFill>
          <p:spPr>
            <a:xfrm>
              <a:off x="9102841" y="1737934"/>
              <a:ext cx="1684169" cy="273417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76DA07AA-8753-4907-B78C-A6E637B8F6D2}"/>
                </a:ext>
              </a:extLst>
            </p:cNvPr>
            <p:cNvSpPr txBox="1"/>
            <p:nvPr/>
          </p:nvSpPr>
          <p:spPr>
            <a:xfrm>
              <a:off x="10793790" y="1689976"/>
              <a:ext cx="8290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43 </a:t>
              </a:r>
              <a:r>
                <a:rPr lang="en-US" dirty="0" err="1"/>
                <a:t>kDa</a:t>
              </a:r>
              <a:endParaRPr lang="en-US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6E569279-5F5F-4E4C-A889-D1F961535DDB}"/>
                </a:ext>
              </a:extLst>
            </p:cNvPr>
            <p:cNvSpPr txBox="1"/>
            <p:nvPr/>
          </p:nvSpPr>
          <p:spPr>
            <a:xfrm>
              <a:off x="8257370" y="1689976"/>
              <a:ext cx="83869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dirty="0"/>
                <a:t>β</a:t>
              </a:r>
              <a:r>
                <a:rPr lang="en-US" dirty="0"/>
                <a:t>-actin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19828D03-5A35-491B-B769-3792C10AB9E9}"/>
                </a:ext>
              </a:extLst>
            </p:cNvPr>
            <p:cNvSpPr txBox="1"/>
            <p:nvPr/>
          </p:nvSpPr>
          <p:spPr>
            <a:xfrm>
              <a:off x="8657221" y="1350609"/>
              <a:ext cx="4187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err="1"/>
                <a:t>gB</a:t>
              </a:r>
              <a:endParaRPr lang="en-US" dirty="0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FF60487D-2062-49F8-A282-A129E9045279}"/>
                </a:ext>
              </a:extLst>
            </p:cNvPr>
            <p:cNvSpPr txBox="1"/>
            <p:nvPr/>
          </p:nvSpPr>
          <p:spPr>
            <a:xfrm>
              <a:off x="10781825" y="1314659"/>
              <a:ext cx="94609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30 </a:t>
              </a:r>
              <a:r>
                <a:rPr lang="en-US" dirty="0" err="1"/>
                <a:t>kDa</a:t>
              </a:r>
              <a:endParaRPr lang="en-US" dirty="0"/>
            </a:p>
          </p:txBody>
        </p:sp>
      </p:grpSp>
      <p:pic>
        <p:nvPicPr>
          <p:cNvPr id="12" name="Picture 11">
            <a:extLst>
              <a:ext uri="{FF2B5EF4-FFF2-40B4-BE49-F238E27FC236}">
                <a16:creationId xmlns:a16="http://schemas.microsoft.com/office/drawing/2014/main" id="{C3493A4D-18CF-4082-8B37-134D257D44D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l="19186" t="2243" r="17695" b="6284"/>
          <a:stretch/>
        </p:blipFill>
        <p:spPr>
          <a:xfrm>
            <a:off x="4544568" y="182880"/>
            <a:ext cx="6044184" cy="3160067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E2044735-03F5-4AC7-A9C4-4B889694E316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rcRect l="21538" t="-243" r="17011" b="4984"/>
          <a:stretch/>
        </p:blipFill>
        <p:spPr>
          <a:xfrm>
            <a:off x="4639056" y="3429000"/>
            <a:ext cx="5775960" cy="3275858"/>
          </a:xfrm>
          <a:prstGeom prst="rect">
            <a:avLst/>
          </a:prstGeom>
        </p:spPr>
      </p:pic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DE9496C4-2423-4C86-B48A-DACE7781B737}"/>
              </a:ext>
            </a:extLst>
          </p:cNvPr>
          <p:cNvCxnSpPr/>
          <p:nvPr/>
        </p:nvCxnSpPr>
        <p:spPr>
          <a:xfrm flipV="1">
            <a:off x="2575905" y="473411"/>
            <a:ext cx="2063151" cy="10171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C63D6D42-A627-45B5-88E0-CB6FD945D8A0}"/>
              </a:ext>
            </a:extLst>
          </p:cNvPr>
          <p:cNvCxnSpPr/>
          <p:nvPr/>
        </p:nvCxnSpPr>
        <p:spPr>
          <a:xfrm>
            <a:off x="2478024" y="1170103"/>
            <a:ext cx="2161032" cy="293555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B772D9F0-D74E-415D-94AF-1771205DAB70}"/>
              </a:ext>
            </a:extLst>
          </p:cNvPr>
          <p:cNvCxnSpPr/>
          <p:nvPr/>
        </p:nvCxnSpPr>
        <p:spPr>
          <a:xfrm flipH="1">
            <a:off x="10332720" y="1170103"/>
            <a:ext cx="39319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6417497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85BBA434-7A38-4E51-ABBD-FF8E648C9630}"/>
              </a:ext>
            </a:extLst>
          </p:cNvPr>
          <p:cNvGrpSpPr/>
          <p:nvPr/>
        </p:nvGrpSpPr>
        <p:grpSpPr>
          <a:xfrm>
            <a:off x="100584" y="638002"/>
            <a:ext cx="3072728" cy="588522"/>
            <a:chOff x="1323658" y="1295020"/>
            <a:chExt cx="3072728" cy="588522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C2FDF1EF-7C18-4221-9225-D0076C28177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20000"/>
                      </a14:imgEffect>
                    </a14:imgLayer>
                  </a14:imgProps>
                </a:ext>
              </a:extLst>
            </a:blip>
            <a:srcRect l="44206" t="34215" r="38149" b="60040"/>
            <a:stretch/>
          </p:blipFill>
          <p:spPr>
            <a:xfrm>
              <a:off x="2014873" y="1295020"/>
              <a:ext cx="1737332" cy="279401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2BA098F5-3E69-41F2-B5E7-486F622E1E5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contrast="20000"/>
                      </a14:imgEffect>
                    </a14:imgLayer>
                  </a14:imgProps>
                </a:ext>
              </a:extLst>
            </a:blip>
            <a:srcRect l="45114" t="26416" r="38622" b="68393"/>
            <a:stretch/>
          </p:blipFill>
          <p:spPr>
            <a:xfrm>
              <a:off x="2014873" y="1612608"/>
              <a:ext cx="1726598" cy="270934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0639AA37-FB51-49D4-8572-023431ED52E2}"/>
                </a:ext>
              </a:extLst>
            </p:cNvPr>
            <p:cNvSpPr txBox="1"/>
            <p:nvPr/>
          </p:nvSpPr>
          <p:spPr>
            <a:xfrm>
              <a:off x="3718280" y="1603235"/>
              <a:ext cx="6703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43 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5BA0D999-DFD6-4ED3-B611-3860F27C0C00}"/>
                </a:ext>
              </a:extLst>
            </p:cNvPr>
            <p:cNvSpPr txBox="1"/>
            <p:nvPr/>
          </p:nvSpPr>
          <p:spPr>
            <a:xfrm>
              <a:off x="3726010" y="1306795"/>
              <a:ext cx="6703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95 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2965C812-1143-4D86-B5A2-8B0A95B36DD1}"/>
                </a:ext>
              </a:extLst>
            </p:cNvPr>
            <p:cNvSpPr txBox="1"/>
            <p:nvPr/>
          </p:nvSpPr>
          <p:spPr>
            <a:xfrm>
              <a:off x="1372435" y="1301752"/>
              <a:ext cx="69281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GC1</a:t>
              </a:r>
              <a:r>
                <a:rPr lang="el-GR" sz="12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6459DAF5-854D-4622-BFD3-B9AF461B4704}"/>
                </a:ext>
              </a:extLst>
            </p:cNvPr>
            <p:cNvSpPr txBox="1"/>
            <p:nvPr/>
          </p:nvSpPr>
          <p:spPr>
            <a:xfrm>
              <a:off x="1323658" y="1583081"/>
              <a:ext cx="69121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 actin</a:t>
              </a:r>
            </a:p>
          </p:txBody>
        </p:sp>
      </p:grpSp>
      <p:pic>
        <p:nvPicPr>
          <p:cNvPr id="12" name="Picture 11">
            <a:extLst>
              <a:ext uri="{FF2B5EF4-FFF2-40B4-BE49-F238E27FC236}">
                <a16:creationId xmlns:a16="http://schemas.microsoft.com/office/drawing/2014/main" id="{F6BB2A7E-6A36-4CF1-96D7-AA0E514EAC2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rcRect l="19350" t="20678" r="16911" b="57166"/>
          <a:stretch/>
        </p:blipFill>
        <p:spPr>
          <a:xfrm>
            <a:off x="4358668" y="266493"/>
            <a:ext cx="6275804" cy="1077565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C114A9C2-5875-44AE-85BF-58DBF183DA9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rcRect l="22374" t="12153" r="18600" b="55632"/>
          <a:stretch/>
        </p:blipFill>
        <p:spPr>
          <a:xfrm>
            <a:off x="4295321" y="1744999"/>
            <a:ext cx="6275804" cy="1684002"/>
          </a:xfrm>
          <a:prstGeom prst="rect">
            <a:avLst/>
          </a:prstGeom>
        </p:spPr>
      </p:pic>
      <p:sp>
        <p:nvSpPr>
          <p:cNvPr id="19" name="Rectangle 18">
            <a:extLst>
              <a:ext uri="{FF2B5EF4-FFF2-40B4-BE49-F238E27FC236}">
                <a16:creationId xmlns:a16="http://schemas.microsoft.com/office/drawing/2014/main" id="{C659633A-8131-402A-8C65-B7554308CD3A}"/>
              </a:ext>
            </a:extLst>
          </p:cNvPr>
          <p:cNvSpPr/>
          <p:nvPr/>
        </p:nvSpPr>
        <p:spPr>
          <a:xfrm>
            <a:off x="6336792" y="788276"/>
            <a:ext cx="1664208" cy="43494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36ABBFBD-CFD4-4343-A861-90AEAB05C554}"/>
              </a:ext>
            </a:extLst>
          </p:cNvPr>
          <p:cNvCxnSpPr/>
          <p:nvPr/>
        </p:nvCxnSpPr>
        <p:spPr>
          <a:xfrm flipV="1">
            <a:off x="2412694" y="266493"/>
            <a:ext cx="1945974" cy="37150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63085D75-093C-40BA-AAA8-71986BC2C9AC}"/>
              </a:ext>
            </a:extLst>
          </p:cNvPr>
          <p:cNvCxnSpPr/>
          <p:nvPr/>
        </p:nvCxnSpPr>
        <p:spPr>
          <a:xfrm>
            <a:off x="2412694" y="1203062"/>
            <a:ext cx="1945974" cy="112149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7382074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470ADE4B-0397-46D7-8031-E638054A2D43}"/>
              </a:ext>
            </a:extLst>
          </p:cNvPr>
          <p:cNvGrpSpPr/>
          <p:nvPr/>
        </p:nvGrpSpPr>
        <p:grpSpPr>
          <a:xfrm>
            <a:off x="349636" y="653996"/>
            <a:ext cx="2870407" cy="658939"/>
            <a:chOff x="2779295" y="1831938"/>
            <a:chExt cx="2870407" cy="658939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A7F37A31-104F-4D32-ABB7-B94FC952924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60143" t="48264" r="20832" b="42971"/>
            <a:stretch/>
          </p:blipFill>
          <p:spPr>
            <a:xfrm>
              <a:off x="3429183" y="1831938"/>
              <a:ext cx="1550143" cy="352309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F615F96A-C75E-4774-BF82-8FD95FC69B4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2265" t="37304" r="20524" b="57046"/>
            <a:stretch/>
          </p:blipFill>
          <p:spPr>
            <a:xfrm>
              <a:off x="3429183" y="2213878"/>
              <a:ext cx="1550143" cy="247368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D94B79B5-415C-4910-94F6-D9A8A91065D7}"/>
                </a:ext>
              </a:extLst>
            </p:cNvPr>
            <p:cNvSpPr txBox="1"/>
            <p:nvPr/>
          </p:nvSpPr>
          <p:spPr>
            <a:xfrm>
              <a:off x="4979326" y="1844546"/>
              <a:ext cx="6703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22 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A66609FD-10E6-4E2F-8E0D-FDAFA46BAAAD}"/>
                </a:ext>
              </a:extLst>
            </p:cNvPr>
            <p:cNvSpPr txBox="1"/>
            <p:nvPr/>
          </p:nvSpPr>
          <p:spPr>
            <a:xfrm>
              <a:off x="4979326" y="2213878"/>
              <a:ext cx="6703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43 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331B0B68-92F5-4021-B7DD-2C0C64A7B1D4}"/>
                </a:ext>
              </a:extLst>
            </p:cNvPr>
            <p:cNvSpPr txBox="1"/>
            <p:nvPr/>
          </p:nvSpPr>
          <p:spPr>
            <a:xfrm>
              <a:off x="2779295" y="2199062"/>
              <a:ext cx="69121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 actin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BCE0A357-6F42-4284-8D4D-076E5FA6015B}"/>
                </a:ext>
              </a:extLst>
            </p:cNvPr>
            <p:cNvSpPr txBox="1"/>
            <p:nvPr/>
          </p:nvSpPr>
          <p:spPr>
            <a:xfrm>
              <a:off x="2832994" y="1898802"/>
              <a:ext cx="59618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FAM</a:t>
              </a:r>
            </a:p>
          </p:txBody>
        </p:sp>
      </p:grpSp>
      <p:pic>
        <p:nvPicPr>
          <p:cNvPr id="13" name="Picture 12">
            <a:extLst>
              <a:ext uri="{FF2B5EF4-FFF2-40B4-BE49-F238E27FC236}">
                <a16:creationId xmlns:a16="http://schemas.microsoft.com/office/drawing/2014/main" id="{C999C3B9-6FAC-49E6-AD27-B8478CA5AD1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8458" t="23515" r="20382" b="52076"/>
          <a:stretch/>
        </p:blipFill>
        <p:spPr>
          <a:xfrm>
            <a:off x="4114062" y="2256252"/>
            <a:ext cx="5508434" cy="1068636"/>
          </a:xfrm>
          <a:prstGeom prst="rect">
            <a:avLst/>
          </a:prstGeom>
        </p:spPr>
      </p:pic>
      <p:grpSp>
        <p:nvGrpSpPr>
          <p:cNvPr id="21" name="Group 20">
            <a:extLst>
              <a:ext uri="{FF2B5EF4-FFF2-40B4-BE49-F238E27FC236}">
                <a16:creationId xmlns:a16="http://schemas.microsoft.com/office/drawing/2014/main" id="{67410C4C-64E5-45EF-BEB3-5F563BABFF74}"/>
              </a:ext>
            </a:extLst>
          </p:cNvPr>
          <p:cNvGrpSpPr/>
          <p:nvPr/>
        </p:nvGrpSpPr>
        <p:grpSpPr>
          <a:xfrm>
            <a:off x="4417764" y="22209"/>
            <a:ext cx="5508434" cy="2114888"/>
            <a:chOff x="4638101" y="1035936"/>
            <a:chExt cx="5508434" cy="2114888"/>
          </a:xfrm>
        </p:grpSpPr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8B5E1C95-89E8-4098-A528-BCF0A48ED9B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6259" t="29263" r="16136" b="18121"/>
            <a:stretch/>
          </p:blipFill>
          <p:spPr>
            <a:xfrm>
              <a:off x="4638101" y="1035936"/>
              <a:ext cx="5508434" cy="2114888"/>
            </a:xfrm>
            <a:prstGeom prst="rect">
              <a:avLst/>
            </a:prstGeom>
          </p:spPr>
        </p:pic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B14C8F81-5033-4CB9-883B-03550EF92655}"/>
                </a:ext>
              </a:extLst>
            </p:cNvPr>
            <p:cNvSpPr/>
            <p:nvPr/>
          </p:nvSpPr>
          <p:spPr>
            <a:xfrm>
              <a:off x="8196550" y="1817783"/>
              <a:ext cx="1520328" cy="418641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77EC1882-D535-4060-BA3D-F6318908AFD8}"/>
              </a:ext>
            </a:extLst>
          </p:cNvPr>
          <p:cNvCxnSpPr>
            <a:cxnSpLocks/>
            <a:stCxn id="5" idx="3"/>
          </p:cNvCxnSpPr>
          <p:nvPr/>
        </p:nvCxnSpPr>
        <p:spPr>
          <a:xfrm flipV="1">
            <a:off x="2549667" y="418908"/>
            <a:ext cx="1868097" cy="41124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93E4267B-4721-4856-848E-AE6A54A430D7}"/>
              </a:ext>
            </a:extLst>
          </p:cNvPr>
          <p:cNvCxnSpPr/>
          <p:nvPr/>
        </p:nvCxnSpPr>
        <p:spPr>
          <a:xfrm>
            <a:off x="2368627" y="1283304"/>
            <a:ext cx="1685580" cy="111837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5825181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>
            <a:extLst>
              <a:ext uri="{FF2B5EF4-FFF2-40B4-BE49-F238E27FC236}">
                <a16:creationId xmlns:a16="http://schemas.microsoft.com/office/drawing/2014/main" id="{7A635E95-A4D7-4086-AC5E-6A1F8044BBE9}"/>
              </a:ext>
            </a:extLst>
          </p:cNvPr>
          <p:cNvGrpSpPr/>
          <p:nvPr/>
        </p:nvGrpSpPr>
        <p:grpSpPr>
          <a:xfrm>
            <a:off x="181718" y="351437"/>
            <a:ext cx="3155355" cy="539328"/>
            <a:chOff x="684638" y="1439573"/>
            <a:chExt cx="3155355" cy="539328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4C2F0754-873B-4CBD-97AA-4CCC884418DF}"/>
                </a:ext>
              </a:extLst>
            </p:cNvPr>
            <p:cNvGrpSpPr/>
            <p:nvPr/>
          </p:nvGrpSpPr>
          <p:grpSpPr>
            <a:xfrm>
              <a:off x="1335528" y="1484937"/>
              <a:ext cx="1755241" cy="492840"/>
              <a:chOff x="2059622" y="3434861"/>
              <a:chExt cx="1860375" cy="469375"/>
            </a:xfrm>
          </p:grpSpPr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9C0FF001-B20C-4223-86B7-A13B7D71876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rcRect l="25011" t="27003" r="57319" b="69072"/>
              <a:stretch/>
            </p:blipFill>
            <p:spPr>
              <a:xfrm>
                <a:off x="2059622" y="3434861"/>
                <a:ext cx="1860375" cy="204077"/>
              </a:xfrm>
              <a:prstGeom prst="rect">
                <a:avLst/>
              </a:prstGeom>
            </p:spPr>
          </p:pic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74E7C448-DA0E-4B8D-A848-899D732BE3C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rcRect l="27370" t="26895" r="55244" b="68849"/>
              <a:stretch/>
            </p:blipFill>
            <p:spPr>
              <a:xfrm>
                <a:off x="2059622" y="3680301"/>
                <a:ext cx="1860375" cy="223935"/>
              </a:xfrm>
              <a:prstGeom prst="rect">
                <a:avLst/>
              </a:prstGeom>
            </p:spPr>
          </p:pic>
        </p:grp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0297EECB-FD1D-4FA6-9466-59FE04C97D08}"/>
                </a:ext>
              </a:extLst>
            </p:cNvPr>
            <p:cNvSpPr txBox="1"/>
            <p:nvPr/>
          </p:nvSpPr>
          <p:spPr>
            <a:xfrm>
              <a:off x="3067023" y="1701902"/>
              <a:ext cx="77297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(43 kDa)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4D87B386-F29B-46E4-8634-55E788448BCA}"/>
                </a:ext>
              </a:extLst>
            </p:cNvPr>
            <p:cNvSpPr txBox="1"/>
            <p:nvPr/>
          </p:nvSpPr>
          <p:spPr>
            <a:xfrm>
              <a:off x="3067023" y="1439573"/>
              <a:ext cx="77297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(42 kDa)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A10961BB-21B9-430A-8173-2D955016804B}"/>
                </a:ext>
              </a:extLst>
            </p:cNvPr>
            <p:cNvSpPr txBox="1"/>
            <p:nvPr/>
          </p:nvSpPr>
          <p:spPr>
            <a:xfrm>
              <a:off x="684638" y="1700775"/>
              <a:ext cx="69121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 actin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382EA500-DA35-4677-A255-593F74EB0077}"/>
                </a:ext>
              </a:extLst>
            </p:cNvPr>
            <p:cNvSpPr txBox="1"/>
            <p:nvPr/>
          </p:nvSpPr>
          <p:spPr>
            <a:xfrm>
              <a:off x="768594" y="1473093"/>
              <a:ext cx="6126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ZBP1</a:t>
              </a:r>
            </a:p>
          </p:txBody>
        </p:sp>
      </p:grpSp>
      <p:pic>
        <p:nvPicPr>
          <p:cNvPr id="19" name="Picture 18">
            <a:extLst>
              <a:ext uri="{FF2B5EF4-FFF2-40B4-BE49-F238E27FC236}">
                <a16:creationId xmlns:a16="http://schemas.microsoft.com/office/drawing/2014/main" id="{D19698E4-ED1E-4A72-B162-38CF71ECC49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rcRect l="21538" t="2641" r="20930" b="48284"/>
          <a:stretch/>
        </p:blipFill>
        <p:spPr>
          <a:xfrm>
            <a:off x="4700016" y="128016"/>
            <a:ext cx="5715000" cy="2679192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733A80D6-1306-4AEE-BB3C-D97AF87D345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rcRect l="22988" t="1795" r="20888" b="49710"/>
          <a:stretch/>
        </p:blipFill>
        <p:spPr>
          <a:xfrm>
            <a:off x="4700016" y="3429000"/>
            <a:ext cx="5666231" cy="2679192"/>
          </a:xfrm>
          <a:prstGeom prst="rect">
            <a:avLst/>
          </a:prstGeom>
        </p:spPr>
      </p:pic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A06016CC-BFB2-4773-BE83-5861CBA9E856}"/>
              </a:ext>
            </a:extLst>
          </p:cNvPr>
          <p:cNvCxnSpPr/>
          <p:nvPr/>
        </p:nvCxnSpPr>
        <p:spPr>
          <a:xfrm flipV="1">
            <a:off x="2496312" y="210312"/>
            <a:ext cx="2203704" cy="18648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8293130F-19BD-43C0-BDD2-D1BEDD7D4153}"/>
              </a:ext>
            </a:extLst>
          </p:cNvPr>
          <p:cNvCxnSpPr/>
          <p:nvPr/>
        </p:nvCxnSpPr>
        <p:spPr>
          <a:xfrm>
            <a:off x="2395728" y="813816"/>
            <a:ext cx="2304288" cy="271576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949676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74</Words>
  <Application>Microsoft Office PowerPoint</Application>
  <PresentationFormat>Widescreen</PresentationFormat>
  <Paragraphs>32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shra, Paras Kumar K</dc:creator>
  <cp:lastModifiedBy>Mishra, Paras Kumar K</cp:lastModifiedBy>
  <cp:revision>15</cp:revision>
  <dcterms:created xsi:type="dcterms:W3CDTF">2022-12-20T15:54:19Z</dcterms:created>
  <dcterms:modified xsi:type="dcterms:W3CDTF">2022-12-20T16:17:56Z</dcterms:modified>
</cp:coreProperties>
</file>